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png" ContentType="image/png"/>
  <Override PartName="/ppt/media/image9.png" ContentType="image/pn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C0ACBB-B559-4503-8943-FB3BAC238BC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灯片编号占位符 1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C45F3B-3A2E-4F18-A4B1-5AD4CEED656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灯片编号占位符 1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305052-31DB-4352-9BA4-690125FE70B5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灯片编号占位符 1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7FA500-F223-4FFC-8EBE-B167B89FAE4E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灯片编号占位符 1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CA0796-C2E3-4D1A-B08E-4B1EC1C5A9F7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C48CC-A220-4F54-B80E-61F661C6D2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1B47D-6C56-441F-92CF-E287C32E40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D75C0-DD0E-46F4-A72C-ED0C021576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C941C-E6F9-410F-B6F7-2E45AC6E50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74473-1857-4E40-BC9A-204522DCFA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91F36-CB22-41C4-83CF-96A1F67E2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FC3AD-9648-4583-A00A-49E894A2E2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E54017-6066-4082-8FF6-52B4BB902B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CF8F3-CF17-4608-B3E0-01E6DC38F4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0EFE9-4968-4148-A7C7-FF22016F14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C2F7E-69E9-46F8-8D8A-B4361085D9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8C24A-AD7F-464A-A9DB-466299455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50165F-7F14-40FF-A2DF-6BDA499AB86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3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5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8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9.png"/><Relationship Id="rId7" Type="http://schemas.openxmlformats.org/officeDocument/2006/relationships/slideLayout" Target="../slideLayouts/slideLayout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本框 83971"/>
          <p:cNvSpPr/>
          <p:nvPr/>
        </p:nvSpPr>
        <p:spPr>
          <a:xfrm>
            <a:off x="380880" y="533520"/>
            <a:ext cx="838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Primers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sed to amplify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open reading frame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304920" y="2743200"/>
          <a:ext cx="8153280" cy="1066680"/>
        </p:xfrm>
        <a:graphic>
          <a:graphicData uri="http://schemas.openxmlformats.org/drawingml/2006/table">
            <a:tbl>
              <a:tblPr/>
              <a:tblGrid>
                <a:gridCol w="2567160"/>
                <a:gridCol w="1487160"/>
                <a:gridCol w="4098960"/>
              </a:tblGrid>
              <a:tr h="355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 and Gene I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568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AR2.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00402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TCATTTCTTGGTCTTCGTCT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5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TTGTCCTTCTTGCGCTTCTCGAC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457200" y="1981080"/>
          <a:ext cx="8077320" cy="3703680"/>
        </p:xfrm>
        <a:graphic>
          <a:graphicData uri="http://schemas.openxmlformats.org/drawingml/2006/table">
            <a:tbl>
              <a:tblPr/>
              <a:tblGrid>
                <a:gridCol w="2543040"/>
                <a:gridCol w="1473480"/>
                <a:gridCol w="4060800"/>
              </a:tblGrid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name and Gene I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AR2.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00402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CGTCGAGAAGCGCAAG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CCACTGAAGCTGCGAACT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RT2.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00851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TCATCCGCGACAAC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GCGAGCCTGGAGAA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RT2.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10973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ACCGGCGGCATGGAC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TCTTCGCCTTGTGC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NRT2.3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10977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CATCCACAAGATCGGTA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TGGAGCTTCCCGTAGTT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Actin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04731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581040"/>
                          <a:tab algn="l" pos="1163520"/>
                          <a:tab algn="l" pos="1744560"/>
                          <a:tab algn="l" pos="2327400"/>
                          <a:tab algn="l" pos="2908440"/>
                          <a:tab algn="l" pos="3489480"/>
                          <a:tab algn="l" pos="4071960"/>
                          <a:tab algn="l" pos="4653000"/>
                          <a:tab algn="l" pos="5235480"/>
                          <a:tab algn="l" pos="5816520"/>
                          <a:tab algn="l" pos="6397560"/>
                          <a:tab algn="l" pos="6980400"/>
                          <a:tab algn="l" pos="7561440"/>
                          <a:tab algn="l" pos="8143920"/>
                          <a:tab algn="l" pos="8724960"/>
                          <a:tab algn="l" pos="9306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GATTACCATGGCCTCAAGA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’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（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</a:t>
                      </a:r>
                      <a:r>
                        <a:rPr b="0" lang="zh-CN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）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CGTATCTTCCCCATGAA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1" name="矩形 122170"/>
          <p:cNvSpPr/>
          <p:nvPr/>
        </p:nvSpPr>
        <p:spPr>
          <a:xfrm>
            <a:off x="462960" y="456480"/>
            <a:ext cx="789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2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imers used for quantitative real-time polymerase chain reactio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矩形 200801"/>
          <p:cNvSpPr/>
          <p:nvPr/>
        </p:nvSpPr>
        <p:spPr>
          <a:xfrm>
            <a:off x="304920" y="456840"/>
            <a:ext cx="85341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omparison of grain yield, dry weight, and agronomic nitrogen-use efficiency (ANUE) between the wild-type (WT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OsNAR2.1: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ransgenic lines in the T2–T4 generation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533520" y="1981080"/>
          <a:ext cx="8076960" cy="3441960"/>
        </p:xfrm>
        <a:graphic>
          <a:graphicData uri="http://schemas.openxmlformats.org/drawingml/2006/table">
            <a:tbl>
              <a:tblPr/>
              <a:tblGrid>
                <a:gridCol w="1218960"/>
                <a:gridCol w="1219320"/>
                <a:gridCol w="838080"/>
                <a:gridCol w="838440"/>
                <a:gridCol w="838080"/>
                <a:gridCol w="838080"/>
                <a:gridCol w="990720"/>
                <a:gridCol w="1295280"/>
              </a:tblGrid>
              <a:tr h="4060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ra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ca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as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ain Yiel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5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8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7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1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nj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. to Oc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g/m</a:t>
                      </a:r>
                      <a:r>
                        <a:rPr b="0" lang="en-US" sz="16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2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4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4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7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ny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c. to Apr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6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0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9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nj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. to Oc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y Weigh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8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4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0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9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nj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. to Oc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g/m</a:t>
                      </a:r>
                      <a:r>
                        <a:rPr b="0" lang="en-US" sz="16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0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7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6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9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ny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c. to Apr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4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8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3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0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nj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. to Oc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U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.24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.33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.96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26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nj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. to Oc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/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.23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.92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.67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.63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ny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c. to Apr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.44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.06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.82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.15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nj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y. to Oc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"/>
          <p:cNvGraphicFramePr/>
          <p:nvPr/>
        </p:nvGraphicFramePr>
        <p:xfrm>
          <a:off x="76320" y="2182680"/>
          <a:ext cx="8915400" cy="3227400"/>
        </p:xfrm>
        <a:graphic>
          <a:graphicData uri="http://schemas.openxmlformats.org/drawingml/2006/table">
            <a:tbl>
              <a:tblPr/>
              <a:tblGrid>
                <a:gridCol w="4038480"/>
                <a:gridCol w="838080"/>
                <a:gridCol w="838440"/>
                <a:gridCol w="838080"/>
                <a:gridCol w="762120"/>
                <a:gridCol w="761760"/>
                <a:gridCol w="838440"/>
              </a:tblGrid>
              <a:tr h="3445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NAR2.1:OsNAR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NAR2.1:OsNRT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creased compared with WT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ysiological nitrogen use efficiency (PNUE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9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itrogen harvest index (NHI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4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y matter translocation efficiency (DMTE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9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4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020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ibution of pre-anthesis assimilates to grain yield (CPAY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6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arvest index (HI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0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6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5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itrogen translocation efficiency (NTE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4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020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ibution of pre-anthesis N to grain nitrogen accumulation (CPNGN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7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7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5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5.3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5.0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6.9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矩形 238844"/>
          <p:cNvSpPr/>
          <p:nvPr/>
        </p:nvSpPr>
        <p:spPr>
          <a:xfrm>
            <a:off x="228600" y="591480"/>
            <a:ext cx="8610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Increased nitrogen-use efficiency i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OsNAR2.1: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OsNAR2.1:OsNRT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ransgenic plants relative to wild-type (WT)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矩形 129025"/>
          <p:cNvSpPr/>
          <p:nvPr/>
        </p:nvSpPr>
        <p:spPr>
          <a:xfrm>
            <a:off x="457200" y="546840"/>
            <a:ext cx="79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Diagram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OsNAR2.1:OsNAR2.1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struct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533520" y="2666880"/>
            <a:ext cx="8305560" cy="88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内容占位符 265217"/>
          <p:cNvGraphicFramePr/>
          <p:nvPr/>
        </p:nvGraphicFramePr>
        <p:xfrm>
          <a:off x="762120" y="3908520"/>
          <a:ext cx="7543800" cy="23400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9" name="内容占位符 26521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2120" y="3908520"/>
                    <a:ext cx="754380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矩形 265218"/>
          <p:cNvSpPr/>
          <p:nvPr/>
        </p:nvSpPr>
        <p:spPr>
          <a:xfrm>
            <a:off x="380880" y="471600"/>
            <a:ext cx="670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haracterization of T1 generation transgenic line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65221"/>
          <p:cNvSpPr/>
          <p:nvPr/>
        </p:nvSpPr>
        <p:spPr>
          <a:xfrm>
            <a:off x="1447920" y="369396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"/>
          <p:cNvGraphicFramePr/>
          <p:nvPr/>
        </p:nvGraphicFramePr>
        <p:xfrm>
          <a:off x="762120" y="1469880"/>
          <a:ext cx="7518240" cy="23400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6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62120" y="1469880"/>
                    <a:ext cx="7518240" cy="23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4" name="文本框 265220"/>
          <p:cNvSpPr/>
          <p:nvPr/>
        </p:nvSpPr>
        <p:spPr>
          <a:xfrm>
            <a:off x="1447920" y="124128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"/>
          <p:cNvSpPr/>
          <p:nvPr/>
        </p:nvSpPr>
        <p:spPr>
          <a:xfrm>
            <a:off x="304920" y="349200"/>
            <a:ext cx="8610480" cy="71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Ratio of 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1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H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o 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1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influx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wild-type (WT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OsNAR2.1: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ansgenic plants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 1.25 mM NH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" name=""/>
          <p:cNvGrpSpPr/>
          <p:nvPr/>
        </p:nvGrpSpPr>
        <p:grpSpPr>
          <a:xfrm>
            <a:off x="168120" y="1828800"/>
            <a:ext cx="8670960" cy="2492280"/>
            <a:chOff x="168120" y="1828800"/>
            <a:chExt cx="8670960" cy="2492280"/>
          </a:xfrm>
        </p:grpSpPr>
        <p:graphicFrame>
          <p:nvGraphicFramePr>
            <p:cNvPr id="67" name="文本占位符 1026"/>
            <p:cNvGraphicFramePr/>
            <p:nvPr/>
          </p:nvGraphicFramePr>
          <p:xfrm>
            <a:off x="5924520" y="1981080"/>
            <a:ext cx="2914560" cy="23385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68" name="文本占位符 102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924520" y="1981080"/>
                      <a:ext cx="2914560" cy="2338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9" name=""/>
            <p:cNvGraphicFramePr/>
            <p:nvPr/>
          </p:nvGraphicFramePr>
          <p:xfrm>
            <a:off x="168120" y="1981080"/>
            <a:ext cx="2880000" cy="233856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70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68120" y="1981080"/>
                      <a:ext cx="2880000" cy="2338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71" name=""/>
            <p:cNvGraphicFramePr/>
            <p:nvPr/>
          </p:nvGraphicFramePr>
          <p:xfrm>
            <a:off x="3063960" y="1981080"/>
            <a:ext cx="2879640" cy="234000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72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3063960" y="1981080"/>
                      <a:ext cx="2879640" cy="23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3" name=""/>
            <p:cNvSpPr/>
            <p:nvPr/>
          </p:nvSpPr>
          <p:spPr>
            <a:xfrm>
              <a:off x="6781680" y="1828800"/>
              <a:ext cx="53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(c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219320" y="1828800"/>
              <a:ext cx="533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(a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041720" y="1828800"/>
              <a:ext cx="53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(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"/>
          <p:cNvGrpSpPr/>
          <p:nvPr/>
        </p:nvGrpSpPr>
        <p:grpSpPr>
          <a:xfrm>
            <a:off x="2133720" y="2286000"/>
            <a:ext cx="4038480" cy="3438360"/>
            <a:chOff x="2133720" y="2286000"/>
            <a:chExt cx="4038480" cy="3438360"/>
          </a:xfrm>
        </p:grpSpPr>
        <p:graphicFrame>
          <p:nvGraphicFramePr>
            <p:cNvPr id="77" name="文本占位符 1026"/>
            <p:cNvGraphicFramePr/>
            <p:nvPr/>
          </p:nvGraphicFramePr>
          <p:xfrm>
            <a:off x="2133720" y="2286000"/>
            <a:ext cx="4038480" cy="34383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78" name="文本占位符 102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133720" y="2286000"/>
                      <a:ext cx="4038480" cy="3438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79" name=""/>
            <p:cNvGrpSpPr/>
            <p:nvPr/>
          </p:nvGrpSpPr>
          <p:grpSpPr>
            <a:xfrm>
              <a:off x="4114800" y="4419720"/>
              <a:ext cx="1676520" cy="456840"/>
              <a:chOff x="4114800" y="4419720"/>
              <a:chExt cx="1676520" cy="456840"/>
            </a:xfrm>
          </p:grpSpPr>
          <p:graphicFrame>
            <p:nvGraphicFramePr>
              <p:cNvPr id="80" name="文本占位符 1026"/>
              <p:cNvGraphicFramePr/>
              <p:nvPr/>
            </p:nvGraphicFramePr>
            <p:xfrm>
              <a:off x="4114800" y="4419720"/>
              <a:ext cx="324360" cy="451800"/>
            </p:xfrm>
            <a:graphic>
              <a:graphicData uri="http://schemas.openxmlformats.org/presentationml/2006/ole">
                <p:oleObj progId="Excel.Sheet.12" r:id="rId3" spid="">
                  <p:embed/>
                  <p:pic>
                    <p:nvPicPr>
                      <p:cNvPr id="81" name="文本占位符 1026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4114800" y="4419720"/>
                        <a:ext cx="324360" cy="451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82" name="文本占位符 1026"/>
              <p:cNvGraphicFramePr/>
              <p:nvPr/>
            </p:nvGraphicFramePr>
            <p:xfrm>
              <a:off x="4457160" y="4424760"/>
              <a:ext cx="1334160" cy="451800"/>
            </p:xfrm>
            <a:graphic>
              <a:graphicData uri="http://schemas.openxmlformats.org/presentationml/2006/ole">
                <p:oleObj progId="Excel.Sheet.12" r:id="rId5" spid="">
                  <p:embed/>
                  <p:pic>
                    <p:nvPicPr>
                      <p:cNvPr id="83" name="文本占位符 1026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4457160" y="4424760"/>
                        <a:ext cx="1334160" cy="45180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</p:grpSp>
      <p:sp>
        <p:nvSpPr>
          <p:cNvPr id="84" name=""/>
          <p:cNvSpPr/>
          <p:nvPr/>
        </p:nvSpPr>
        <p:spPr>
          <a:xfrm>
            <a:off x="380880" y="380880"/>
            <a:ext cx="8305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4.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RT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o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expression ratios in culms of wild-type (WT) and transgenic lines over the course of the study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03T13:02:09Z</dcterms:created>
  <dc:creator>Administrator</dc:creator>
  <dc:description/>
  <cp:keywords/>
  <dc:language>en-US</dc:language>
  <cp:lastModifiedBy>User</cp:lastModifiedBy>
  <dcterms:modified xsi:type="dcterms:W3CDTF">2017-02-04T09:06:39Z</dcterms:modified>
  <cp:revision>21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803</vt:lpwstr>
  </property>
  <property fmtid="{D5CDD505-2E9C-101B-9397-08002B2CF9AE}" pid="3" name="Version">
    <vt:r8>1</vt:r8>
  </property>
</Properties>
</file>